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150100" cy="94503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DCB5EA-3C26-4D8E-B687-19027717CAF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3875CF-2C6A-4B2F-9F66-7C74D0DDB6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E0FE0F-9D3A-467A-9E9B-B449B69A59E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099E81-3BF6-4C44-9A26-9D4D59512A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BAC84A-5368-4F1F-B2D2-E7D677C6D3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9F0050-35AA-44BC-AA8C-52EB2A9E41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AE26D1-D135-48FA-B86F-2E5FF1ADCC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BEF87C-7959-45BF-9829-9D213C2590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BBD612-DD04-481B-B0C0-2CA6B78808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1DAD04-E4D4-4B6D-B9ED-CA25AF856F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9E28E6-8DAD-4F5D-A1BD-443B3D09CC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700EA3-9145-4242-B81E-A1C477123D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6DF02E-78E8-4BE9-802F-7CC5D0F1BB7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905120" y="762120"/>
          <a:ext cx="6629400" cy="5721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905120" y="762120"/>
                    <a:ext cx="6629400" cy="5721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761400" y="228600"/>
            <a:ext cx="79898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Window for Network and Disease Association Search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77040" y="5105520"/>
            <a:ext cx="185868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electe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isease to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Highlight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ssociate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Genes in GTA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flipV="1">
            <a:off x="1523880" y="5862240"/>
            <a:ext cx="1071720" cy="4680"/>
          </a:xfrm>
          <a:prstGeom prst="line">
            <a:avLst/>
          </a:prstGeom>
          <a:ln w="5724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06360" y="3581280"/>
            <a:ext cx="18450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Repor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Genes an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erms in GTA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752480" y="4114800"/>
            <a:ext cx="538200" cy="0"/>
          </a:xfrm>
          <a:prstGeom prst="line">
            <a:avLst/>
          </a:prstGeom>
          <a:ln w="5724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4-18T03:50:59Z</dcterms:created>
  <dc:creator>Ming Yi</dc:creator>
  <dc:description/>
  <dc:language>en-US</dc:language>
  <cp:lastModifiedBy>Ming Yi</cp:lastModifiedBy>
  <dcterms:modified xsi:type="dcterms:W3CDTF">2005-04-27T14:29:28Z</dcterms:modified>
  <cp:revision>11</cp:revision>
  <dc:subject/>
  <dc:title>Slide 1</dc:title>
</cp:coreProperties>
</file>